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1048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A19CB3-5731-3ADE-D770-70814F40D79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b="27698"/>
          <a:stretch/>
        </p:blipFill>
        <p:spPr>
          <a:xfrm>
            <a:off x="2419390" y="1500706"/>
            <a:ext cx="1891367" cy="53132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7593E62-7054-FEC5-8B80-525FE86F387D}"/>
              </a:ext>
            </a:extLst>
          </p:cNvPr>
          <p:cNvSpPr/>
          <p:nvPr/>
        </p:nvSpPr>
        <p:spPr>
          <a:xfrm>
            <a:off x="3857911" y="2612579"/>
            <a:ext cx="346141" cy="6627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9373CB-5360-1A83-0C32-18D4C050F7B7}"/>
              </a:ext>
            </a:extLst>
          </p:cNvPr>
          <p:cNvSpPr txBox="1"/>
          <p:nvPr/>
        </p:nvSpPr>
        <p:spPr>
          <a:xfrm rot="16200000">
            <a:off x="3385680" y="2625204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NA sequencing.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2989F8-7A2D-7402-A2C3-B086E9AD6F91}"/>
              </a:ext>
            </a:extLst>
          </p:cNvPr>
          <p:cNvSpPr txBox="1"/>
          <p:nvPr/>
        </p:nvSpPr>
        <p:spPr>
          <a:xfrm rot="16200000">
            <a:off x="3521476" y="2632364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uenc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.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C74CBB0-EDD6-2984-E8B8-51F2624590D5}"/>
              </a:ext>
            </a:extLst>
          </p:cNvPr>
          <p:cNvSpPr txBox="1"/>
          <p:nvPr/>
        </p:nvSpPr>
        <p:spPr>
          <a:xfrm>
            <a:off x="310630" y="29565"/>
            <a:ext cx="1157074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pplementary Fig. 5 Ingenuity pathway analysis (IPA) predictions for common DEGs among RNAseq vs. scRNAseq in all PCa cell lines </a:t>
            </a:r>
          </a:p>
          <a:p>
            <a:pPr algn="just"/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just"/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PA predicted A)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Diseases and biological pathways for common DGEs. Major pathways are cell invasion, movement, neoplasia, migration, transformation, metastatic and growth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)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Causal network pathway for common DEGS include LY2109761 (TGF-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β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receptor inhibitor), IGF2R (receptor for both insulin-like growth factor 2), IL11RA (cytokine), SEMG2 (semenogelin proteins), CCR2 (chemokine receptor type 2), TRAF3IP3 (mediates cell growth by modulating the c-Jun N-terminal kinase signal transduction pathway), GGTI-2154 (inhibitor of geranylgeranyltransferase I ), L778123 (inhibitor of FPTase and GGPTase-I), TGFB1 and CXCL5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upstream regulators for common DEGs were THBF1, RAF1, AGT, ER receptor, OSM, SLC15A4, JUN, and IL1B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D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anonical pathways for common DEGs were s100 family, Hepatic fibrosis, Rho family, RHOGDI and integrin singling pathway.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4D3B412-19CA-D196-B168-97C626EEA1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0190"/>
          <a:stretch/>
        </p:blipFill>
        <p:spPr>
          <a:xfrm>
            <a:off x="4358098" y="1504893"/>
            <a:ext cx="2066925" cy="53061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5059E360-B936-9940-0748-0F92504756EA}"/>
              </a:ext>
            </a:extLst>
          </p:cNvPr>
          <p:cNvSpPr/>
          <p:nvPr/>
        </p:nvSpPr>
        <p:spPr>
          <a:xfrm>
            <a:off x="6015142" y="2488798"/>
            <a:ext cx="318782" cy="7508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C524C50-4F2D-BC66-983D-05A2827D9989}"/>
              </a:ext>
            </a:extLst>
          </p:cNvPr>
          <p:cNvSpPr/>
          <p:nvPr/>
        </p:nvSpPr>
        <p:spPr>
          <a:xfrm>
            <a:off x="6018864" y="2569892"/>
            <a:ext cx="276837" cy="6627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030C0B-35D1-8771-90ED-1609E4EAB1CD}"/>
              </a:ext>
            </a:extLst>
          </p:cNvPr>
          <p:cNvSpPr txBox="1"/>
          <p:nvPr/>
        </p:nvSpPr>
        <p:spPr>
          <a:xfrm rot="16200000">
            <a:off x="5502216" y="2587366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NA sequencing.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5D18F5-9B3E-FB70-6898-4986CD883B12}"/>
              </a:ext>
            </a:extLst>
          </p:cNvPr>
          <p:cNvSpPr txBox="1"/>
          <p:nvPr/>
        </p:nvSpPr>
        <p:spPr>
          <a:xfrm rot="16200000">
            <a:off x="5638012" y="2594526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uenc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.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9804902-2667-6F55-131B-EE337B27E9C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1" b="68737"/>
          <a:stretch/>
        </p:blipFill>
        <p:spPr>
          <a:xfrm>
            <a:off x="6485747" y="1510882"/>
            <a:ext cx="1824893" cy="52968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3F73DCC7-EA60-A1D7-F5CC-57E5CD007FE6}"/>
              </a:ext>
            </a:extLst>
          </p:cNvPr>
          <p:cNvSpPr/>
          <p:nvPr/>
        </p:nvSpPr>
        <p:spPr>
          <a:xfrm>
            <a:off x="7920817" y="2542927"/>
            <a:ext cx="322499" cy="7053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538173C-9CB4-2AE6-8CB0-C8D56DB19FDF}"/>
              </a:ext>
            </a:extLst>
          </p:cNvPr>
          <p:cNvSpPr txBox="1"/>
          <p:nvPr/>
        </p:nvSpPr>
        <p:spPr>
          <a:xfrm rot="16200000">
            <a:off x="7403215" y="2601320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NA sequencing.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781F14-AFEE-FF9C-07C8-9C409281410D}"/>
              </a:ext>
            </a:extLst>
          </p:cNvPr>
          <p:cNvSpPr txBox="1"/>
          <p:nvPr/>
        </p:nvSpPr>
        <p:spPr>
          <a:xfrm rot="16200000">
            <a:off x="7539011" y="2608480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uenc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..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43475704-DF03-A831-9736-406330C1698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0444"/>
          <a:stretch/>
        </p:blipFill>
        <p:spPr>
          <a:xfrm>
            <a:off x="8370143" y="1504893"/>
            <a:ext cx="1891366" cy="53109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20D09C13-CCA7-1F0D-7771-11F2E2F96F52}"/>
              </a:ext>
            </a:extLst>
          </p:cNvPr>
          <p:cNvSpPr/>
          <p:nvPr/>
        </p:nvSpPr>
        <p:spPr>
          <a:xfrm>
            <a:off x="9849394" y="2203269"/>
            <a:ext cx="339042" cy="10938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3857A16-1687-7EB6-3C46-BDFF7C7DFEE1}"/>
              </a:ext>
            </a:extLst>
          </p:cNvPr>
          <p:cNvSpPr txBox="1"/>
          <p:nvPr/>
        </p:nvSpPr>
        <p:spPr>
          <a:xfrm rot="16200000">
            <a:off x="9339871" y="2640859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NA sequencing.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1AD2CE9-8AFD-7AE9-5AAA-2C242DC52E9D}"/>
              </a:ext>
            </a:extLst>
          </p:cNvPr>
          <p:cNvSpPr txBox="1"/>
          <p:nvPr/>
        </p:nvSpPr>
        <p:spPr>
          <a:xfrm rot="16200000">
            <a:off x="9475667" y="2648019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uenc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.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337B248-3DA7-5BC1-45D1-55C723B12929}"/>
              </a:ext>
            </a:extLst>
          </p:cNvPr>
          <p:cNvSpPr txBox="1"/>
          <p:nvPr/>
        </p:nvSpPr>
        <p:spPr>
          <a:xfrm>
            <a:off x="4522965" y="1285918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en-US" sz="11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C3B98CE-D782-F81D-3A62-BD46B40F86D3}"/>
              </a:ext>
            </a:extLst>
          </p:cNvPr>
          <p:cNvSpPr txBox="1"/>
          <p:nvPr/>
        </p:nvSpPr>
        <p:spPr>
          <a:xfrm>
            <a:off x="2473458" y="1291616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5A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43C5F88-8D40-6E5C-3C3C-DE157B700EC6}"/>
              </a:ext>
            </a:extLst>
          </p:cNvPr>
          <p:cNvSpPr txBox="1"/>
          <p:nvPr/>
        </p:nvSpPr>
        <p:spPr>
          <a:xfrm>
            <a:off x="6555054" y="1294740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5C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7AE2F98-1F41-62DE-2A41-51ACCA51D63F}"/>
              </a:ext>
            </a:extLst>
          </p:cNvPr>
          <p:cNvSpPr txBox="1"/>
          <p:nvPr/>
        </p:nvSpPr>
        <p:spPr>
          <a:xfrm>
            <a:off x="8390088" y="1298579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5D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8500495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217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2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0:39Z</dcterms:modified>
</cp:coreProperties>
</file>